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3CFBDA-8EE8-4409-A6DB-A0284701D2F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8EA07B-D245-4045-9016-BE3792B312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87B933-BC51-4989-B79C-EBDF2A2413D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1A879F-9E26-4CE3-A8AF-F215ADD5485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C78172-D808-453F-BB32-6535548166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08B3CE-547D-4428-8CA4-0DF7A38EB8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4F21CC-BE08-43D9-9C30-9552B8312E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AD6801-AAA0-4DB4-B7C5-768E928C99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4B3CDE-CAEB-4FC3-BAAB-985D9EB8DF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0E2A0B-683A-480F-BC6A-C865E27FA1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7A6D5B-32B9-44C9-AC72-4EDD9DBB61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8701CC-73B7-41E1-91A1-FC50C12D25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l-G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l-G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l-G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7EAE341-0529-49B7-BB93-26624CC578D3}" type="slidenum">
              <a:rPr b="0" lang="el-G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52280" y="304920"/>
            <a:ext cx="8610840" cy="3781440"/>
            <a:chOff x="152280" y="304920"/>
            <a:chExt cx="8610840" cy="3781440"/>
          </a:xfrm>
        </p:grpSpPr>
        <p:sp>
          <p:nvSpPr>
            <p:cNvPr id="42" name=""/>
            <p:cNvSpPr/>
            <p:nvPr/>
          </p:nvSpPr>
          <p:spPr>
            <a:xfrm>
              <a:off x="152280" y="304920"/>
              <a:ext cx="8610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Table S2: Fold differences of microRNAs detected by SYBR Green microRNA Real-time PCR assay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"/>
            <p:cNvGrpSpPr/>
            <p:nvPr/>
          </p:nvGrpSpPr>
          <p:grpSpPr>
            <a:xfrm>
              <a:off x="673200" y="841320"/>
              <a:ext cx="7797600" cy="3245040"/>
              <a:chOff x="673200" y="841320"/>
              <a:chExt cx="7797600" cy="3245040"/>
            </a:xfrm>
          </p:grpSpPr>
          <p:sp>
            <p:nvSpPr>
              <p:cNvPr id="44" name=""/>
              <p:cNvSpPr/>
              <p:nvPr/>
            </p:nvSpPr>
            <p:spPr>
              <a:xfrm>
                <a:off x="3505320" y="3809880"/>
                <a:ext cx="4724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microRNAs in this list are &gt;2 fold deregulate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6603840" y="3556080"/>
                <a:ext cx="16257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/>
              </a:bodyPr>
              <a:p>
                <a:pPr>
                  <a:spcBef>
                    <a:spcPts val="300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4495680" y="3556080"/>
                <a:ext cx="21081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/>
              </a:bodyPr>
              <a:p>
                <a:pPr>
                  <a:spcBef>
                    <a:spcPts val="300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2717640" y="3556080"/>
                <a:ext cx="14097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2,74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673200" y="3556080"/>
                <a:ext cx="204444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hsa-</a:t>
                </a:r>
                <a:r>
                  <a:rPr b="0" lang="el-GR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miR-509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6603840" y="3281400"/>
                <a:ext cx="16257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/>
              </a:bodyPr>
              <a:p>
                <a:pPr>
                  <a:spcBef>
                    <a:spcPts val="300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4495680" y="3281400"/>
                <a:ext cx="21081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/>
              </a:bodyPr>
              <a:p>
                <a:pPr>
                  <a:spcBef>
                    <a:spcPts val="300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2717640" y="3281400"/>
                <a:ext cx="14097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2,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673200" y="3281400"/>
                <a:ext cx="204444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hsa-</a:t>
                </a:r>
                <a:r>
                  <a:rPr b="0" lang="el-GR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miR-23b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6603840" y="3006720"/>
                <a:ext cx="16257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-</a:t>
                </a:r>
                <a:r>
                  <a:rPr b="0" lang="el-GR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2,</a:t>
                </a:r>
                <a:r>
                  <a:rPr b="0" lang="en-US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4495680" y="3006720"/>
                <a:ext cx="21081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hsa-</a:t>
                </a:r>
                <a:r>
                  <a:rPr b="0" lang="el-GR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miR-373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2717640" y="3006720"/>
                <a:ext cx="14097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5,62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673200" y="3006720"/>
                <a:ext cx="204444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hsa-</a:t>
                </a:r>
                <a:r>
                  <a:rPr b="0" lang="el-GR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miR-30b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6603840" y="2732040"/>
                <a:ext cx="16257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l-GR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-2,</a:t>
                </a:r>
                <a:r>
                  <a:rPr b="0" lang="en-US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4495680" y="2732040"/>
                <a:ext cx="21081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hsa-</a:t>
                </a:r>
                <a:r>
                  <a:rPr b="0" lang="el-GR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miR-26a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2717640" y="2732040"/>
                <a:ext cx="14097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4,63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673200" y="2732040"/>
                <a:ext cx="204444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hsa-</a:t>
                </a:r>
                <a:r>
                  <a:rPr b="0" lang="el-GR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miR-223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6603840" y="2457360"/>
                <a:ext cx="16257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-3,4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4495680" y="2457360"/>
                <a:ext cx="21081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hsa-</a:t>
                </a:r>
                <a:r>
                  <a:rPr b="0" lang="el-GR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miR-210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2717640" y="2457360"/>
                <a:ext cx="14097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3,67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673200" y="2457360"/>
                <a:ext cx="204444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hsa-</a:t>
                </a:r>
                <a:r>
                  <a:rPr b="0" lang="el-GR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miR-</a:t>
                </a:r>
                <a:r>
                  <a:rPr b="0" lang="en-US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16</a:t>
                </a:r>
                <a:r>
                  <a:rPr b="0" lang="el-GR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6603840" y="2182680"/>
                <a:ext cx="16257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-2,3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4495680" y="2182680"/>
                <a:ext cx="21081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hsa-</a:t>
                </a:r>
                <a:r>
                  <a:rPr b="0" lang="el-GR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miR-337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2717640" y="2182680"/>
                <a:ext cx="14097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2,45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673200" y="2182680"/>
                <a:ext cx="204444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hsa-</a:t>
                </a:r>
                <a:r>
                  <a:rPr b="0" lang="el-GR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miR-103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6603840" y="1908000"/>
                <a:ext cx="16257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-2,6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4495680" y="1908000"/>
                <a:ext cx="21081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hsa-</a:t>
                </a:r>
                <a:r>
                  <a:rPr b="0" lang="el-GR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miR-25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4127400" y="1908000"/>
                <a:ext cx="60984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/>
              </a:bodyPr>
              <a:p>
                <a:pPr>
                  <a:spcBef>
                    <a:spcPts val="300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2717640" y="1908000"/>
                <a:ext cx="14097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4,76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673200" y="1908000"/>
                <a:ext cx="204444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hsa-</a:t>
                </a:r>
                <a:r>
                  <a:rPr b="0" lang="el-GR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miR-377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6603840" y="1633680"/>
                <a:ext cx="162576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-4,3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4495680" y="1633680"/>
                <a:ext cx="210816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hsa-</a:t>
                </a:r>
                <a:r>
                  <a:rPr b="0" lang="el-GR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miR-140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2717640" y="1633680"/>
                <a:ext cx="140976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5,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673200" y="1633680"/>
                <a:ext cx="204444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hsa-</a:t>
                </a:r>
                <a:r>
                  <a:rPr b="0" lang="el-GR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miR-22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6603840" y="1359000"/>
                <a:ext cx="16257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-5,2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4495680" y="1359000"/>
                <a:ext cx="21081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hsa-</a:t>
                </a:r>
                <a:r>
                  <a:rPr b="0" lang="el-GR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miR-29a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2717640" y="1359000"/>
                <a:ext cx="14097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8,34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673200" y="1359000"/>
                <a:ext cx="204444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 fontScale="99000"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hsa-</a:t>
                </a:r>
                <a:r>
                  <a:rPr b="0" lang="el-GR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miR-48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6603840" y="841320"/>
                <a:ext cx="1625760" cy="517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FOLD CHANG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4495680" y="841320"/>
                <a:ext cx="2108160" cy="517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9966"/>
                    </a:solidFill>
                    <a:latin typeface="Arial"/>
                    <a:ea typeface="Arial"/>
                  </a:rPr>
                  <a:t>DOWN-REGULATE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2717640" y="841320"/>
                <a:ext cx="1409760" cy="517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FOLD CHANG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673200" y="841320"/>
                <a:ext cx="2044440" cy="517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UP-REGULATE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673200" y="841320"/>
                <a:ext cx="7797600" cy="0"/>
              </a:xfrm>
              <a:prstGeom prst="line">
                <a:avLst/>
              </a:prstGeom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673200" y="841320"/>
                <a:ext cx="0" cy="2989440"/>
              </a:xfrm>
              <a:prstGeom prst="line">
                <a:avLst/>
              </a:prstGeom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673200" y="1359000"/>
                <a:ext cx="3454200" cy="0"/>
              </a:xfrm>
              <a:prstGeom prst="line">
                <a:avLst/>
              </a:prstGeom>
              <a:ln cap="rnd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4495680" y="1359000"/>
                <a:ext cx="3733920" cy="0"/>
              </a:xfrm>
              <a:prstGeom prst="line">
                <a:avLst/>
              </a:prstGeom>
              <a:ln cap="rnd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Dimitrios</cp:lastModifiedBy>
  <dcterms:modified xsi:type="dcterms:W3CDTF">2008-10-31T02:29:28Z</dcterms:modified>
  <cp:revision>106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